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501" autoAdjust="0"/>
    <p:restoredTop sz="94660"/>
  </p:normalViewPr>
  <p:slideViewPr>
    <p:cSldViewPr snapToGrid="0">
      <p:cViewPr>
        <p:scale>
          <a:sx n="150" d="100"/>
          <a:sy n="150" d="100"/>
        </p:scale>
        <p:origin x="2250" y="-47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5901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21412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698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46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7847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391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47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69187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641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7431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3495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F933513-7942-40EB-833A-5849304EE6C6}" type="datetimeFigureOut">
              <a:rPr lang="en-US" smtClean="0"/>
              <a:t>7/1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9C26EB2-9D9D-4943-8F00-EB5D5D038F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8643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">
            <a:extLst>
              <a:ext uri="{FF2B5EF4-FFF2-40B4-BE49-F238E27FC236}">
                <a16:creationId xmlns:a16="http://schemas.microsoft.com/office/drawing/2014/main" id="{7B0B3576-9ABD-95CF-45CD-3A7A1AB8937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3939" y="4294901"/>
            <a:ext cx="3294061" cy="3639181"/>
          </a:xfrm>
          <a:prstGeom prst="rect">
            <a:avLst/>
          </a:prstGeom>
        </p:spPr>
      </p:pic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24C77113-0C2C-3E5C-A710-3ED34BD68F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6846" y="4304805"/>
            <a:ext cx="3294061" cy="3639181"/>
          </a:xfrm>
          <a:prstGeom prst="rect">
            <a:avLst/>
          </a:prstGeom>
        </p:spPr>
      </p:pic>
      <p:pic>
        <p:nvPicPr>
          <p:cNvPr id="9" name="Picture 8" descr="A screenshot of a computer&#10;&#10;Description automatically generated">
            <a:extLst>
              <a:ext uri="{FF2B5EF4-FFF2-40B4-BE49-F238E27FC236}">
                <a16:creationId xmlns:a16="http://schemas.microsoft.com/office/drawing/2014/main" id="{14DBB08A-CAC3-955A-D5EE-77FC4D2E86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63939" y="435666"/>
            <a:ext cx="3294061" cy="3639181"/>
          </a:xfrm>
          <a:prstGeom prst="rect">
            <a:avLst/>
          </a:prstGeom>
        </p:spPr>
      </p:pic>
      <p:pic>
        <p:nvPicPr>
          <p:cNvPr id="11" name="Picture 10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0BAE9E28-3DBA-5E80-0D3E-EB005B5DC5E1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53" y="425647"/>
            <a:ext cx="3303447" cy="36492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09C5C4C6-BA29-AC44-82E9-BAF02BE74E2D}"/>
              </a:ext>
            </a:extLst>
          </p:cNvPr>
          <p:cNvSpPr txBox="1"/>
          <p:nvPr/>
        </p:nvSpPr>
        <p:spPr>
          <a:xfrm>
            <a:off x="58084" y="342255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29FE7291-81DF-7793-0133-2B50873B3125}"/>
              </a:ext>
            </a:extLst>
          </p:cNvPr>
          <p:cNvSpPr txBox="1"/>
          <p:nvPr/>
        </p:nvSpPr>
        <p:spPr>
          <a:xfrm>
            <a:off x="3764998" y="342255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D692528-56E4-2C2C-88A7-C91A04489984}"/>
              </a:ext>
            </a:extLst>
          </p:cNvPr>
          <p:cNvSpPr txBox="1"/>
          <p:nvPr/>
        </p:nvSpPr>
        <p:spPr>
          <a:xfrm>
            <a:off x="64496" y="4120139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8216ED-B291-ED42-A7FC-A49F0EB03A9F}"/>
              </a:ext>
            </a:extLst>
          </p:cNvPr>
          <p:cNvSpPr txBox="1"/>
          <p:nvPr/>
        </p:nvSpPr>
        <p:spPr>
          <a:xfrm>
            <a:off x="3752174" y="4120139"/>
            <a:ext cx="4283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3D3E615-25AD-5EC6-5B9C-8CC4C4AB0B0A}"/>
              </a:ext>
            </a:extLst>
          </p:cNvPr>
          <p:cNvSpPr txBox="1"/>
          <p:nvPr/>
        </p:nvSpPr>
        <p:spPr>
          <a:xfrm>
            <a:off x="272245" y="8173944"/>
            <a:ext cx="625809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nctional enrichment analysis of DEGs related to seedling-shoot tissue identified through microarray meta-analysis (group 3) in the context of drought using STRING. A) Top 20 enriched Gene Ontology (GO) terms for Biological Processes; B) Top 20 enriched GO terms for Molecular Functions; C) Top 20 enriched GO terms for Cellular Components; D) Top KEGG enriched terms. All graphs are displayed with the x-axis representing strength and the y-axis representing the enriched terms.</a:t>
            </a:r>
          </a:p>
        </p:txBody>
      </p:sp>
    </p:spTree>
    <p:extLst>
      <p:ext uri="{BB962C8B-B14F-4D97-AF65-F5344CB8AC3E}">
        <p14:creationId xmlns:p14="http://schemas.microsoft.com/office/powerpoint/2010/main" val="19259442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8</TotalTime>
  <Words>98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PA MARIA</dc:creator>
  <cp:lastModifiedBy>KAMPA MARIA</cp:lastModifiedBy>
  <cp:revision>16</cp:revision>
  <dcterms:created xsi:type="dcterms:W3CDTF">2025-01-13T16:07:29Z</dcterms:created>
  <dcterms:modified xsi:type="dcterms:W3CDTF">2025-07-16T04:23:52Z</dcterms:modified>
</cp:coreProperties>
</file>